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88" r:id="rId3"/>
    <p:sldId id="286" r:id="rId4"/>
    <p:sldId id="29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4675"/>
  </p:normalViewPr>
  <p:slideViewPr>
    <p:cSldViewPr snapToGrid="0" snapToObjects="1">
      <p:cViewPr varScale="1">
        <p:scale>
          <a:sx n="117" d="100"/>
          <a:sy n="117" d="100"/>
        </p:scale>
        <p:origin x="36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B297D2-ADAD-784A-8CD3-4B9DBD2AD4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00FA638-0817-3A4C-A258-BA34837673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21B533-E788-9A42-8A47-E7AC97EA04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8EC0-A12B-9F4D-BBC6-1BE83437982C}" type="datetimeFigureOut">
              <a:rPr lang="en-US" smtClean="0"/>
              <a:t>1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36B1D1-E23F-CF49-97A5-32EA9256B5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B7B918-F11B-2645-845B-4AA2202F76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E41A4-1E63-274F-8110-04B0AF967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4727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AF2793-4D1F-6346-A141-FBA20307A9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DE4D63E-93B8-FA4F-A7B3-B667A3A426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A73BD0-3CDE-8A43-97B8-DFB6BA40DC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8EC0-A12B-9F4D-BBC6-1BE83437982C}" type="datetimeFigureOut">
              <a:rPr lang="en-US" smtClean="0"/>
              <a:t>1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3E7E4F-DB5C-9D48-B560-89020D247D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9C432C-8B3F-0F47-A717-271D2921D7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E41A4-1E63-274F-8110-04B0AF967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2228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BDCF141-E721-134E-A8A9-CBACA09113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9D2D4F-59AB-794B-90F6-86F3D59CD0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B248F3-8559-4345-B793-8F2917105C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8EC0-A12B-9F4D-BBC6-1BE83437982C}" type="datetimeFigureOut">
              <a:rPr lang="en-US" smtClean="0"/>
              <a:t>1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C864AF-32C2-634A-B352-51131DF6AF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CBC0A8-103A-734D-B05B-CA81B576A4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E41A4-1E63-274F-8110-04B0AF967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2368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E6EC4D-2FB6-C34A-BBCB-1D673D9249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1C0B18-8F11-6D46-85AC-0C157985AD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871BB0-EAEA-C345-A196-8BC7222DDD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8EC0-A12B-9F4D-BBC6-1BE83437982C}" type="datetimeFigureOut">
              <a:rPr lang="en-US" smtClean="0"/>
              <a:t>1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E9F4C8-EC4A-1F46-832C-40CE205BDE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5B85DB-E509-6E44-9047-88F0541FE0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E41A4-1E63-274F-8110-04B0AF967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438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BE8304-A6DF-9240-A8B0-74AA1109A3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B22FD0-FC2A-B041-AA3E-344C717026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41903E-57BE-9A4B-A85B-423EF755C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8EC0-A12B-9F4D-BBC6-1BE83437982C}" type="datetimeFigureOut">
              <a:rPr lang="en-US" smtClean="0"/>
              <a:t>1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C23737-2404-3E49-B241-C2A0C1A0AD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5858B0-8C38-A94A-865B-3B5DFFF240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E41A4-1E63-274F-8110-04B0AF967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2200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7A05A7-5526-5246-B915-A56F593B36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53B341-BA5A-B04D-99F9-10D686AA9C9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7E7B93-9286-B347-9DD6-69954B4853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648D38-A6BB-FC4D-83A0-A03CC8FEF4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8EC0-A12B-9F4D-BBC6-1BE83437982C}" type="datetimeFigureOut">
              <a:rPr lang="en-US" smtClean="0"/>
              <a:t>11/1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6C3653-BFC8-8A4B-BEF6-97F908BD79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1D9AB8-A58F-EF46-B9DE-422D6904C0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E41A4-1E63-274F-8110-04B0AF967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8476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16284C-3147-2E46-B612-720294B017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7AD254-1CA3-DB4B-B1F0-53791A737E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7FACF4-38CB-5A4C-B827-AB70766572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3DC85C0-766C-D541-A56D-B91A228827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7069362-B30F-364E-B344-AEB639BFD25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31BA2AE-64A8-A84A-B42D-3FA5C7415D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8EC0-A12B-9F4D-BBC6-1BE83437982C}" type="datetimeFigureOut">
              <a:rPr lang="en-US" smtClean="0"/>
              <a:t>11/13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825AF62-E418-CD49-A0C3-835BA5492E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E380CDC-65D7-DA4E-AA75-1AB89B40FB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E41A4-1E63-274F-8110-04B0AF967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8581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C2B2FB-E004-C547-91D9-392EDD310D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7738765-F6CA-934E-AEE1-86434DED8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8EC0-A12B-9F4D-BBC6-1BE83437982C}" type="datetimeFigureOut">
              <a:rPr lang="en-US" smtClean="0"/>
              <a:t>11/13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4563DFF-3014-C241-AE72-ACBC0F9917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075D9E2-0C87-6440-ABA6-85BBB7C978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E41A4-1E63-274F-8110-04B0AF967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8446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21C0622-23D2-4846-BFB6-0A663C650F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8EC0-A12B-9F4D-BBC6-1BE83437982C}" type="datetimeFigureOut">
              <a:rPr lang="en-US" smtClean="0"/>
              <a:t>11/13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E4D1098-E74A-7240-9B4A-52F0A2273A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1DD256D-614B-AC46-BE8A-EAA1A74935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E41A4-1E63-274F-8110-04B0AF967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1607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31BA18-36BF-414F-AD8A-BEC6F51EAA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4EAD21-022F-4E4B-9301-B367A9E7C11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4DD1FE6-EFB8-E14C-BD5D-757B775C07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7AC30A-9310-3E46-867C-8A16203320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8EC0-A12B-9F4D-BBC6-1BE83437982C}" type="datetimeFigureOut">
              <a:rPr lang="en-US" smtClean="0"/>
              <a:t>11/1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60B1AE-2F3C-2D44-9040-CCEACE52CD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A015B0-92CB-A14E-9E11-3C8C5CC1E8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E41A4-1E63-274F-8110-04B0AF967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8205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BA14AC-2A55-4244-86F1-B8F0DEC0B5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3825F0E-6E7B-254F-B2CF-0647C5BBD8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F263DE5-BDD8-194D-A1DA-86FE633BD6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4A56F6-7DA4-F044-8B42-7AB3BFC0D7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8EC0-A12B-9F4D-BBC6-1BE83437982C}" type="datetimeFigureOut">
              <a:rPr lang="en-US" smtClean="0"/>
              <a:t>11/1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288FAB-1E37-824F-BE41-65EB4913D6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BB4489-76A7-844E-B3D6-C20DD3C2E5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E41A4-1E63-274F-8110-04B0AF967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670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921235B-1EB3-884E-AC27-9DE14E4F23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B13C57-AD19-AD44-B47D-92892877C6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BC5B69-C29A-214B-B458-6317F5A8D9A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298EC0-A12B-9F4D-BBC6-1BE83437982C}" type="datetimeFigureOut">
              <a:rPr lang="en-US" smtClean="0"/>
              <a:t>11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EF3498-2757-9A41-8EAB-9182C9ACD5D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7F1E48-C6A0-0742-8CD6-5D5D6FEC3F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2E41A4-1E63-274F-8110-04B0AF967F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9027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FB6F7836-3671-E248-B32F-9ED03D5ACC1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471" t="3434" r="2499" b="28824"/>
          <a:stretch/>
        </p:blipFill>
        <p:spPr>
          <a:xfrm>
            <a:off x="6403650" y="148687"/>
            <a:ext cx="4053117" cy="254137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14D8287A-22FD-5841-8230-A9C9F787AA6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9265" t="7843" r="11470" b="25294"/>
          <a:stretch/>
        </p:blipFill>
        <p:spPr>
          <a:xfrm>
            <a:off x="7360023" y="2867361"/>
            <a:ext cx="2564083" cy="1856375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9D1AC9F-8161-6F48-BE9F-FF3D38A13CA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4559" t="11765" r="8382" b="43137"/>
          <a:stretch/>
        </p:blipFill>
        <p:spPr>
          <a:xfrm>
            <a:off x="6300985" y="4723737"/>
            <a:ext cx="4053117" cy="204433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A8212C41-9496-AE41-809F-D5D5B558DE4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2941" t="11569" r="3236" b="42549"/>
          <a:stretch/>
        </p:blipFill>
        <p:spPr>
          <a:xfrm>
            <a:off x="1524001" y="469271"/>
            <a:ext cx="4666129" cy="2353235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718FE299-C1D7-B544-8986-7E9953D6871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8824" t="9608" r="11176" b="24117"/>
          <a:stretch/>
        </p:blipFill>
        <p:spPr>
          <a:xfrm>
            <a:off x="1554607" y="3159754"/>
            <a:ext cx="4501909" cy="2797142"/>
          </a:xfrm>
          <a:prstGeom prst="rect">
            <a:avLst/>
          </a:prstGeom>
        </p:spPr>
      </p:pic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BE21AE5C-7667-4048-ABC8-EC59F75DEC6B}"/>
              </a:ext>
            </a:extLst>
          </p:cNvPr>
          <p:cNvCxnSpPr/>
          <p:nvPr/>
        </p:nvCxnSpPr>
        <p:spPr>
          <a:xfrm>
            <a:off x="1554606" y="2822505"/>
            <a:ext cx="9113394" cy="0"/>
          </a:xfrm>
          <a:prstGeom prst="line">
            <a:avLst/>
          </a:prstGeom>
          <a:ln w="63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1243F3B2-F0E1-D04C-AF4A-730367970102}"/>
              </a:ext>
            </a:extLst>
          </p:cNvPr>
          <p:cNvCxnSpPr>
            <a:cxnSpLocks/>
          </p:cNvCxnSpPr>
          <p:nvPr/>
        </p:nvCxnSpPr>
        <p:spPr>
          <a:xfrm flipH="1">
            <a:off x="6270036" y="0"/>
            <a:ext cx="13803" cy="6858000"/>
          </a:xfrm>
          <a:prstGeom prst="line">
            <a:avLst/>
          </a:prstGeom>
          <a:ln w="63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CFB493BD-9510-FD4B-B49E-4106804E09A4}"/>
              </a:ext>
            </a:extLst>
          </p:cNvPr>
          <p:cNvCxnSpPr>
            <a:cxnSpLocks/>
          </p:cNvCxnSpPr>
          <p:nvPr/>
        </p:nvCxnSpPr>
        <p:spPr>
          <a:xfrm>
            <a:off x="6264094" y="4723736"/>
            <a:ext cx="4403906" cy="0"/>
          </a:xfrm>
          <a:prstGeom prst="line">
            <a:avLst/>
          </a:prstGeom>
          <a:ln w="63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A1318E24-9F5D-854F-A7BD-8DBCDB7DE11F}"/>
              </a:ext>
            </a:extLst>
          </p:cNvPr>
          <p:cNvSpPr txBox="1"/>
          <p:nvPr/>
        </p:nvSpPr>
        <p:spPr>
          <a:xfrm>
            <a:off x="5810470" y="2344800"/>
            <a:ext cx="49237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/>
              <a:t>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C776D6D-DFE2-8148-AA61-04D4B464C100}"/>
              </a:ext>
            </a:extLst>
          </p:cNvPr>
          <p:cNvSpPr txBox="1"/>
          <p:nvPr/>
        </p:nvSpPr>
        <p:spPr>
          <a:xfrm>
            <a:off x="5810470" y="6391502"/>
            <a:ext cx="49237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/>
              <a:t>B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2A7BBF1-E48F-AB41-A213-FA0DC080ED61}"/>
              </a:ext>
            </a:extLst>
          </p:cNvPr>
          <p:cNvSpPr txBox="1"/>
          <p:nvPr/>
        </p:nvSpPr>
        <p:spPr>
          <a:xfrm>
            <a:off x="6379135" y="2349811"/>
            <a:ext cx="49237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/>
              <a:t>C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07C78EF-0776-3144-9B4F-BFB8B92E0704}"/>
              </a:ext>
            </a:extLst>
          </p:cNvPr>
          <p:cNvSpPr txBox="1"/>
          <p:nvPr/>
        </p:nvSpPr>
        <p:spPr>
          <a:xfrm>
            <a:off x="6402436" y="4292849"/>
            <a:ext cx="49237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/>
              <a:t>D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24C1C31-9E30-CC49-A68A-9F4D100CA746}"/>
              </a:ext>
            </a:extLst>
          </p:cNvPr>
          <p:cNvSpPr txBox="1"/>
          <p:nvPr/>
        </p:nvSpPr>
        <p:spPr>
          <a:xfrm>
            <a:off x="6402436" y="6408568"/>
            <a:ext cx="49237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8179400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9EFB1E-AF7D-ED44-93A5-A24E6E995A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79494" y="301532"/>
            <a:ext cx="8229600" cy="1143000"/>
          </a:xfrm>
        </p:spPr>
        <p:txBody>
          <a:bodyPr/>
          <a:lstStyle/>
          <a:p>
            <a:pPr algn="ctr"/>
            <a:r>
              <a:rPr lang="en-US" dirty="0"/>
              <a:t>Supplementary Figure 1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2A825B-C159-E444-B809-AD227B7EC7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Figure 1A: Genogram, Table 1 Patient 5</a:t>
            </a:r>
          </a:p>
          <a:p>
            <a:r>
              <a:rPr lang="en-US" dirty="0"/>
              <a:t>Figure 1B: Genogram, Table 1 Patient 6</a:t>
            </a:r>
          </a:p>
          <a:p>
            <a:r>
              <a:rPr lang="en-US" dirty="0"/>
              <a:t>Figure 1C: Genogram, Table 1 Patient 7</a:t>
            </a:r>
          </a:p>
          <a:p>
            <a:r>
              <a:rPr lang="en-US" dirty="0"/>
              <a:t>Figure 1D: Genogram, Table 1 Patient 8</a:t>
            </a:r>
          </a:p>
          <a:p>
            <a:r>
              <a:rPr lang="en-US" dirty="0"/>
              <a:t>Figure 1E: Genogram, Table 1 Patient 9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077762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E147D5E-64D2-0043-8258-60A99631F20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432" r="10735" b="20588"/>
          <a:stretch/>
        </p:blipFill>
        <p:spPr>
          <a:xfrm>
            <a:off x="1628215" y="403413"/>
            <a:ext cx="4128175" cy="264906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24D694A-D17C-A545-8A66-173624CDE91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1177" t="5098" r="2500" b="43725"/>
          <a:stretch/>
        </p:blipFill>
        <p:spPr>
          <a:xfrm>
            <a:off x="1628215" y="3750752"/>
            <a:ext cx="4356848" cy="264907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353EB11-D0EF-2C4F-A62A-8EB64B3B86B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8823" t="12549" r="3383" b="31176"/>
          <a:stretch/>
        </p:blipFill>
        <p:spPr>
          <a:xfrm>
            <a:off x="5841914" y="229089"/>
            <a:ext cx="4826086" cy="306593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F4B46943-EFDD-244A-A419-B220841B16F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7353" t="7842" r="9853" b="28040"/>
          <a:stretch/>
        </p:blipFill>
        <p:spPr>
          <a:xfrm>
            <a:off x="6311154" y="3979842"/>
            <a:ext cx="4356847" cy="2878159"/>
          </a:xfrm>
          <a:prstGeom prst="rect">
            <a:avLst/>
          </a:prstGeom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B438B444-552B-0646-BA57-8F7E43BFF132}"/>
              </a:ext>
            </a:extLst>
          </p:cNvPr>
          <p:cNvCxnSpPr/>
          <p:nvPr/>
        </p:nvCxnSpPr>
        <p:spPr>
          <a:xfrm>
            <a:off x="1524000" y="3429000"/>
            <a:ext cx="9113394" cy="0"/>
          </a:xfrm>
          <a:prstGeom prst="line">
            <a:avLst/>
          </a:prstGeom>
          <a:ln w="63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F505FD64-8BD4-AA44-AE36-DD4244896D43}"/>
              </a:ext>
            </a:extLst>
          </p:cNvPr>
          <p:cNvCxnSpPr>
            <a:cxnSpLocks/>
          </p:cNvCxnSpPr>
          <p:nvPr/>
        </p:nvCxnSpPr>
        <p:spPr>
          <a:xfrm flipH="1">
            <a:off x="5841916" y="0"/>
            <a:ext cx="1" cy="3429000"/>
          </a:xfrm>
          <a:prstGeom prst="line">
            <a:avLst/>
          </a:prstGeom>
          <a:ln w="63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1293743A-973B-5B40-AED5-70B38528517F}"/>
              </a:ext>
            </a:extLst>
          </p:cNvPr>
          <p:cNvCxnSpPr>
            <a:cxnSpLocks/>
          </p:cNvCxnSpPr>
          <p:nvPr/>
        </p:nvCxnSpPr>
        <p:spPr>
          <a:xfrm>
            <a:off x="6080698" y="3429000"/>
            <a:ext cx="1" cy="3429000"/>
          </a:xfrm>
          <a:prstGeom prst="line">
            <a:avLst/>
          </a:prstGeom>
          <a:ln w="63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B76D5408-2DA4-CE4E-87DB-A2BD512D02C4}"/>
              </a:ext>
            </a:extLst>
          </p:cNvPr>
          <p:cNvSpPr txBox="1"/>
          <p:nvPr/>
        </p:nvSpPr>
        <p:spPr>
          <a:xfrm>
            <a:off x="5492693" y="2971019"/>
            <a:ext cx="49237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/>
              <a:t>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2DA999E-3713-6F41-999B-CEA44FB30D0B}"/>
              </a:ext>
            </a:extLst>
          </p:cNvPr>
          <p:cNvSpPr txBox="1"/>
          <p:nvPr/>
        </p:nvSpPr>
        <p:spPr>
          <a:xfrm>
            <a:off x="5944953" y="2964695"/>
            <a:ext cx="49237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/>
              <a:t>B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F7F04E0-9540-4D4A-870B-DEA14E388C8A}"/>
              </a:ext>
            </a:extLst>
          </p:cNvPr>
          <p:cNvSpPr txBox="1"/>
          <p:nvPr/>
        </p:nvSpPr>
        <p:spPr>
          <a:xfrm>
            <a:off x="5672882" y="3462420"/>
            <a:ext cx="49237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/>
              <a:t>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3F28E54-80CC-1745-A603-432D4D163FEA}"/>
              </a:ext>
            </a:extLst>
          </p:cNvPr>
          <p:cNvSpPr txBox="1"/>
          <p:nvPr/>
        </p:nvSpPr>
        <p:spPr>
          <a:xfrm>
            <a:off x="6176332" y="3462420"/>
            <a:ext cx="49237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200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6269188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9EFB1E-AF7D-ED44-93A5-A24E6E995A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79494" y="301532"/>
            <a:ext cx="8229600" cy="1143000"/>
          </a:xfrm>
        </p:spPr>
        <p:txBody>
          <a:bodyPr/>
          <a:lstStyle/>
          <a:p>
            <a:pPr algn="ctr"/>
            <a:r>
              <a:rPr lang="en-US" dirty="0"/>
              <a:t>Supplementary Figure 2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2A825B-C159-E444-B809-AD227B7EC7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Figure 2A: Genogram, Table 1 Patient 10</a:t>
            </a:r>
          </a:p>
          <a:p>
            <a:r>
              <a:rPr lang="en-US" dirty="0"/>
              <a:t>Figure 2B: Genogram, Table 1 Patient 11</a:t>
            </a:r>
          </a:p>
          <a:p>
            <a:r>
              <a:rPr lang="en-US" dirty="0"/>
              <a:t>Figure 2C: Genogram, Table 1 Patient 12</a:t>
            </a:r>
          </a:p>
          <a:p>
            <a:r>
              <a:rPr lang="en-US" dirty="0"/>
              <a:t>Figure 2D: Genogram, Table 1 Patient 13</a:t>
            </a:r>
          </a:p>
          <a:p>
            <a:pPr marL="0" indent="0">
              <a:buNone/>
            </a:pPr>
            <a:endParaRPr lang="en-US" dirty="0"/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389615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96</Words>
  <Application>Microsoft Macintosh PowerPoint</Application>
  <PresentationFormat>Widescreen</PresentationFormat>
  <Paragraphs>2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Supplementary Figure 1</vt:lpstr>
      <vt:lpstr>PowerPoint Presentation</vt:lpstr>
      <vt:lpstr>Supplementary Figure 2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rold</dc:creator>
  <cp:lastModifiedBy>Jerold</cp:lastModifiedBy>
  <cp:revision>3</cp:revision>
  <dcterms:created xsi:type="dcterms:W3CDTF">2021-08-01T04:55:54Z</dcterms:created>
  <dcterms:modified xsi:type="dcterms:W3CDTF">2021-11-13T11:26:07Z</dcterms:modified>
</cp:coreProperties>
</file>